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75" r:id="rId6"/>
    <p:sldId id="261" r:id="rId7"/>
    <p:sldId id="279" r:id="rId8"/>
    <p:sldId id="262" r:id="rId9"/>
    <p:sldId id="263" r:id="rId10"/>
    <p:sldId id="264" r:id="rId11"/>
    <p:sldId id="272" r:id="rId12"/>
    <p:sldId id="273" r:id="rId13"/>
    <p:sldId id="276" r:id="rId14"/>
    <p:sldId id="277" r:id="rId15"/>
    <p:sldId id="265" r:id="rId16"/>
    <p:sldId id="266" r:id="rId17"/>
    <p:sldId id="278" r:id="rId18"/>
    <p:sldId id="267" r:id="rId19"/>
    <p:sldId id="268" r:id="rId20"/>
    <p:sldId id="269" r:id="rId21"/>
    <p:sldId id="270" r:id="rId22"/>
    <p:sldId id="271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1A6F0-7A02-CE42-888A-1CFEBF40AA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85868DD-1C3F-954B-8213-8E1E940921B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901C3-3409-FE48-9F6B-6E3154ADD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2897C1-3AAC-6A4B-B991-BF4CCCBFA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F776B7-F25A-C04B-9E9F-9B0F8EC9B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57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7B07C-FC88-5E4C-AE6F-9DDA7391A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004D85-2C34-4449-B34C-3DE62F8B7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F7A9A7-3B60-684F-AE73-FD1009E71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157DDA-49A0-8648-A7BF-1448A55B3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EA49A-A359-8E46-9E08-BC7393BEA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4320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9699E69-FA16-B24E-88F8-F157DEC0E3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417504-743B-DB42-B4BE-D567434235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64D3E-2D23-8D40-A3C0-A7B62736A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C658B6-29E9-CA45-B7EE-12D738CBA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EB644B-B0DB-524F-B20C-DC3A53F1B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654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5C090-E1C8-454D-96DB-84E7A0458C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BFE8C9-6A49-924D-A717-DBB5473990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17A25-6222-7E4E-8A94-C3E975E5C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75F859-2D69-1E4B-82A6-53928308D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9C3A9-F44A-424C-8E8C-F0953278F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924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AA5F30-868E-4244-A0FF-8A3A814382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86BD6C-27D3-F24C-A2C0-5E87A5064C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2FF715-B476-E94B-B1A3-8366525A63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E95948-A415-6A4B-B8A6-3759BD97D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67189-E8D7-A343-854A-13D1EF9AD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925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FBEC8-80D3-A548-9D90-3390CC34C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558027-0B1C-F646-B703-D02A1C7DE2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0F02DF-D009-6748-83F8-9401DE0BE1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192DCD-0FD4-B345-B7CC-D10905DB5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F02949-3E30-8542-8E9F-1C7925C0C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6E94C8-0E83-F947-B451-5176FC034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220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18E846-89AB-C546-9379-B844F416E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2CD233-8DE9-9245-8BFB-2A39F847B1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38A54A-82AC-E344-8665-A60BB360BB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6573F0-6872-7546-97C3-2029F6670E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21CB50-4626-0A48-8D6F-C6376A4279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C83C6A-4785-6547-91D7-2CCD1F49D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4BE89A-48E3-B74E-ABE1-DAB673FD22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01DD63-E422-EA46-911E-7419CEC8B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00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EEB0C-AAC2-4E4C-BEA6-9DAD5EBEC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D2FE31-52A0-A443-A877-836D10341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6B271B-E6E3-0C4C-A5FB-B04A44747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15EBA-FA21-064E-B0CB-BD833FDE3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191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986912-58C8-004A-B7BB-A4C833D95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77F901-2341-8A44-B0F0-62A308A98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671DE7-7892-7646-B919-728BC2B9C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265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01759-83A8-1343-8F3E-0A23EE464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D5FAF4-933C-144A-9BCE-70B0F9279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2FB871-023F-F040-9015-4634246257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4BFEC2-70C2-B04A-9EE6-C944CCF7B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CE6F47-0404-2244-AB68-F9D7C43EF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15FE6E-1211-344A-BD76-88D61358C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943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F46B4-B65B-AE4B-9C93-C4A1A39F6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5D5129-C217-754C-BC78-ED63ED1BBE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15F61B-57D8-964A-8682-AF74BC9FC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BEA034-E7D4-5043-89DE-992DD5700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E22257-8BA3-DA48-B91C-93ABBD3E9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77442D-1A9F-3242-A51A-FBAE47046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87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2D0CD6-DE90-2940-B1FA-8239264151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E1D8F-DCC7-3948-B20C-DE4CF28AC5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C2B9D5-6C4D-9040-8B08-9E3FCBFE03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FDDF50-2CB8-D84D-B708-28B18C91FCAE}" type="datetimeFigureOut">
              <a:rPr lang="en-US" smtClean="0"/>
              <a:t>5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825D8B-112D-5243-AA8F-2CA75C7EEA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B6E66A-9D8A-3B44-9AA8-2240304FBF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F8380-C649-A44F-B7CC-A6A13E148C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257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fficeArt object">
            <a:extLst>
              <a:ext uri="{FF2B5EF4-FFF2-40B4-BE49-F238E27FC236}">
                <a16:creationId xmlns:a16="http://schemas.microsoft.com/office/drawing/2014/main" id="{15BD721D-4BC5-CD4A-ABE0-C0DC7852BA73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124200" y="1746802"/>
            <a:ext cx="5943600" cy="44577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  <p:sp>
        <p:nvSpPr>
          <p:cNvPr id="3" name="Title 2">
            <a:extLst>
              <a:ext uri="{FF2B5EF4-FFF2-40B4-BE49-F238E27FC236}">
                <a16:creationId xmlns:a16="http://schemas.microsoft.com/office/drawing/2014/main" id="{34429DDB-AE21-C24E-9E68-5C22F26B3E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kin Exam</a:t>
            </a:r>
          </a:p>
        </p:txBody>
      </p:sp>
    </p:spTree>
    <p:extLst>
      <p:ext uri="{BB962C8B-B14F-4D97-AF65-F5344CB8AC3E}">
        <p14:creationId xmlns:p14="http://schemas.microsoft.com/office/powerpoint/2010/main" val="20792165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51211-A13F-934E-B6C3-146D5462B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hano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B46F4D-8C2B-E743-9B7B-2A8607C471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Ethanol level - 200 mg/dL</a:t>
            </a:r>
          </a:p>
        </p:txBody>
      </p:sp>
    </p:spTree>
    <p:extLst>
      <p:ext uri="{BB962C8B-B14F-4D97-AF65-F5344CB8AC3E}">
        <p14:creationId xmlns:p14="http://schemas.microsoft.com/office/powerpoint/2010/main" val="402065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07443-AD9E-FE46-B6C2-6D9C747F9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alicylat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52B23B-59C3-6F48-93B9-90F301F31E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alicylate level - negative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32182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927E8-0EAC-3A49-8E22-82B074B6E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cetominophen</a:t>
            </a:r>
            <a:r>
              <a:rPr lang="en-US" dirty="0"/>
              <a:t> lev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03FA65-5D96-5C4E-80A7-2BB8A914BD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cetaminophen level - negative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2829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5F697-4101-4B4C-82A2-93B2DD900E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nous blood ga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B0C0E1-723E-2545-AD3E-58B0C6A5CC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H 7.2</a:t>
            </a:r>
          </a:p>
          <a:p>
            <a:r>
              <a:rPr lang="en-US" dirty="0"/>
              <a:t>pCO2 32</a:t>
            </a:r>
          </a:p>
          <a:p>
            <a:r>
              <a:rPr lang="en-US" dirty="0"/>
              <a:t>HCO3 15</a:t>
            </a:r>
          </a:p>
          <a:p>
            <a:r>
              <a:rPr lang="en-US" dirty="0"/>
              <a:t>pO2 83</a:t>
            </a:r>
          </a:p>
          <a:p>
            <a:r>
              <a:rPr lang="en-US" dirty="0"/>
              <a:t>BE -5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957366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EC6149-3FE9-3545-9040-67BA33558C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smolar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2ABA20-A44A-7049-B746-2BF3BFD4E8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Serum osmolarity 295mOsm/kg</a:t>
            </a:r>
          </a:p>
        </p:txBody>
      </p:sp>
    </p:spTree>
    <p:extLst>
      <p:ext uri="{BB962C8B-B14F-4D97-AF65-F5344CB8AC3E}">
        <p14:creationId xmlns:p14="http://schemas.microsoft.com/office/powerpoint/2010/main" val="25997185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D0F546-2F96-8044-BA6F-458713A611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agulation factor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49BA82-4705-6C48-85A7-895641EB61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rothrombin time (PT) 40 seconds</a:t>
            </a:r>
          </a:p>
          <a:p>
            <a:r>
              <a:rPr lang="en-US" dirty="0"/>
              <a:t>Partial thromboplastin time (PTT) 70 sec</a:t>
            </a:r>
          </a:p>
          <a:p>
            <a:r>
              <a:rPr lang="en-US" dirty="0"/>
              <a:t>INR 3.5 </a:t>
            </a:r>
          </a:p>
        </p:txBody>
      </p:sp>
    </p:spTree>
    <p:extLst>
      <p:ext uri="{BB962C8B-B14F-4D97-AF65-F5344CB8AC3E}">
        <p14:creationId xmlns:p14="http://schemas.microsoft.com/office/powerpoint/2010/main" val="71383543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FA7B8A-865D-6D4F-ABAA-74D049ED0D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-dim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159E6E-F76F-1C45-B30C-830F20D8B5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-dimer 500 n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3030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FB487A-9FD9-5745-B907-C456E335A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brinog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4094B3-9960-2C44-B08B-A0FF6F7C18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Fibrinogen 90 </a:t>
            </a:r>
            <a:r>
              <a:rPr lang="en-US" dirty="0"/>
              <a:t>m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353256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62832-99E5-6644-9310-C3F3403BE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eripheral blood smea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7728A7-1A85-1A4F-8F10-1AB696058B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+ Schistocytes</a:t>
            </a:r>
          </a:p>
          <a:p>
            <a:endParaRPr lang="en-US"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86BD186B-B6C8-EA4A-A2F8-98562C1390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5525" y="1382118"/>
            <a:ext cx="6844853" cy="54758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6246387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5E1BB-CF6C-C045-AAED-D8A3A21B12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pic>
        <p:nvPicPr>
          <p:cNvPr id="3" name="officeArt object">
            <a:extLst>
              <a:ext uri="{FF2B5EF4-FFF2-40B4-BE49-F238E27FC236}">
                <a16:creationId xmlns:a16="http://schemas.microsoft.com/office/drawing/2014/main" id="{935B60C5-8163-A640-9996-F2912B5E387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467628" y="365124"/>
            <a:ext cx="5122580" cy="630613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320860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73E33C-9F70-214C-9845-0F5FED868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CG</a:t>
            </a:r>
          </a:p>
        </p:txBody>
      </p:sp>
      <p:pic>
        <p:nvPicPr>
          <p:cNvPr id="3" name="officeArt object">
            <a:extLst>
              <a:ext uri="{FF2B5EF4-FFF2-40B4-BE49-F238E27FC236}">
                <a16:creationId xmlns:a16="http://schemas.microsoft.com/office/drawing/2014/main" id="{A8BACBB8-83C2-F643-A662-84F51417E18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20362" y="1429556"/>
            <a:ext cx="11551276" cy="5241701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355279117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F1560-AE4F-6444-A845-09AFBDA451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T Head</a:t>
            </a:r>
          </a:p>
        </p:txBody>
      </p:sp>
      <p:pic>
        <p:nvPicPr>
          <p:cNvPr id="3" name="officeArt object">
            <a:extLst>
              <a:ext uri="{FF2B5EF4-FFF2-40B4-BE49-F238E27FC236}">
                <a16:creationId xmlns:a16="http://schemas.microsoft.com/office/drawing/2014/main" id="{E1032CDE-5756-0C46-9965-2EAA5BF99BF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5541010" y="365125"/>
            <a:ext cx="4767580" cy="59436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108687827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1B973F-1BBF-7F47-9A5E-0CBE42CA24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st-intubation CXR</a:t>
            </a:r>
          </a:p>
        </p:txBody>
      </p:sp>
      <p:pic>
        <p:nvPicPr>
          <p:cNvPr id="3" name="officeArt object">
            <a:extLst>
              <a:ext uri="{FF2B5EF4-FFF2-40B4-BE49-F238E27FC236}">
                <a16:creationId xmlns:a16="http://schemas.microsoft.com/office/drawing/2014/main" id="{E6AB9994-EC46-0D47-8BCB-6BEDB6D5770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742387" y="1400175"/>
            <a:ext cx="5943600" cy="509270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316194244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4D5743-5ADB-1B48-BC63-84FBB70BDE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IVC</a:t>
            </a:r>
          </a:p>
        </p:txBody>
      </p:sp>
      <p:pic>
        <p:nvPicPr>
          <p:cNvPr id="3" name="officeArt object">
            <a:extLst>
              <a:ext uri="{FF2B5EF4-FFF2-40B4-BE49-F238E27FC236}">
                <a16:creationId xmlns:a16="http://schemas.microsoft.com/office/drawing/2014/main" id="{EDDB4962-0861-B743-8892-8C168903663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124200" y="1690688"/>
            <a:ext cx="5943600" cy="5120640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4244946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05ECE2-FCF1-5C41-8DB7-B27D78197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B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09B5A6-4BBF-334F-BC01-39DD5A33C5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ite blood count (WBC) 25 x 1000/mm</a:t>
            </a:r>
            <a:r>
              <a:rPr lang="en-US" baseline="30000" dirty="0"/>
              <a:t>3 </a:t>
            </a:r>
            <a:r>
              <a:rPr lang="en-US" dirty="0"/>
              <a:t>(H)</a:t>
            </a:r>
          </a:p>
          <a:p>
            <a:r>
              <a:rPr lang="en-US" dirty="0"/>
              <a:t>Hemoglobin (Hgb) 6g/dL</a:t>
            </a:r>
          </a:p>
          <a:p>
            <a:r>
              <a:rPr lang="fr-FR" dirty="0" err="1"/>
              <a:t>Hematocrit</a:t>
            </a:r>
            <a:r>
              <a:rPr lang="fr-FR" dirty="0"/>
              <a:t> (HCT) </a:t>
            </a:r>
            <a:r>
              <a:rPr lang="en-US" dirty="0"/>
              <a:t>17%</a:t>
            </a:r>
            <a:r>
              <a:rPr lang="en-US" dirty="0">
                <a:effectLst/>
              </a:rPr>
              <a:t> </a:t>
            </a:r>
          </a:p>
          <a:p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 20 x 1000/mm</a:t>
            </a:r>
            <a:r>
              <a:rPr lang="en-US" baseline="30000" dirty="0"/>
              <a:t>3 </a:t>
            </a:r>
            <a:r>
              <a:rPr lang="en-US" dirty="0"/>
              <a:t>(H)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20269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88B6CF-5AE4-0549-8049-5785E9948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M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72C2E0-BB53-8441-9981-52C6441FB3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PT" dirty="0" err="1"/>
              <a:t>Sodium</a:t>
            </a:r>
            <a:r>
              <a:rPr lang="pt-PT" dirty="0"/>
              <a:t> 122 </a:t>
            </a:r>
            <a:r>
              <a:rPr lang="pt-PT" dirty="0" err="1"/>
              <a:t>mEq</a:t>
            </a:r>
            <a:r>
              <a:rPr lang="pt-PT" dirty="0"/>
              <a:t>/L</a:t>
            </a:r>
          </a:p>
          <a:p>
            <a:r>
              <a:rPr lang="pt-PT" dirty="0" err="1"/>
              <a:t>Potassium</a:t>
            </a:r>
            <a:r>
              <a:rPr lang="pt-PT" dirty="0"/>
              <a:t> </a:t>
            </a:r>
            <a:r>
              <a:rPr lang="en-US" dirty="0"/>
              <a:t>5</a:t>
            </a:r>
            <a:r>
              <a:rPr lang="pt-PT" dirty="0"/>
              <a:t>.0 </a:t>
            </a:r>
            <a:r>
              <a:rPr lang="pt-PT" dirty="0" err="1"/>
              <a:t>mEq</a:t>
            </a:r>
            <a:r>
              <a:rPr lang="pt-PT" dirty="0"/>
              <a:t>/L</a:t>
            </a:r>
            <a:endParaRPr lang="en-US" dirty="0"/>
          </a:p>
          <a:p>
            <a:r>
              <a:rPr lang="en-US" dirty="0"/>
              <a:t>Chloride 81</a:t>
            </a:r>
            <a:r>
              <a:rPr lang="pt-PT" dirty="0"/>
              <a:t> </a:t>
            </a:r>
            <a:r>
              <a:rPr lang="pt-PT" dirty="0" err="1"/>
              <a:t>mEq</a:t>
            </a:r>
            <a:r>
              <a:rPr lang="pt-PT" dirty="0"/>
              <a:t>/L</a:t>
            </a:r>
            <a:endParaRPr lang="en-US" dirty="0"/>
          </a:p>
          <a:p>
            <a:r>
              <a:rPr lang="it-IT" dirty="0" err="1"/>
              <a:t>Bicarbonate</a:t>
            </a:r>
            <a:r>
              <a:rPr lang="it-IT" dirty="0"/>
              <a:t> (HCO3) </a:t>
            </a:r>
            <a:r>
              <a:rPr lang="en-US" dirty="0"/>
              <a:t>18</a:t>
            </a:r>
            <a:r>
              <a:rPr lang="pt-PT" dirty="0"/>
              <a:t> </a:t>
            </a:r>
            <a:r>
              <a:rPr lang="pt-PT" dirty="0" err="1"/>
              <a:t>mEq</a:t>
            </a:r>
            <a:r>
              <a:rPr lang="pt-PT" dirty="0"/>
              <a:t>/L</a:t>
            </a:r>
            <a:endParaRPr lang="en-US" dirty="0"/>
          </a:p>
          <a:p>
            <a:r>
              <a:rPr lang="nl-NL" dirty="0"/>
              <a:t>Blood </a:t>
            </a:r>
            <a:r>
              <a:rPr lang="nl-NL" dirty="0" err="1"/>
              <a:t>Urea</a:t>
            </a:r>
            <a:r>
              <a:rPr lang="nl-NL" dirty="0"/>
              <a:t> </a:t>
            </a:r>
            <a:r>
              <a:rPr lang="nl-NL" dirty="0" err="1"/>
              <a:t>Nitrogen</a:t>
            </a:r>
            <a:r>
              <a:rPr lang="nl-NL" dirty="0"/>
              <a:t> (BUN) </a:t>
            </a:r>
            <a:r>
              <a:rPr lang="en-US" dirty="0"/>
              <a:t>40 mg/dL</a:t>
            </a:r>
          </a:p>
          <a:p>
            <a:r>
              <a:rPr lang="en-US" dirty="0"/>
              <a:t>Creatinine 2 mg/dL</a:t>
            </a:r>
          </a:p>
          <a:p>
            <a:r>
              <a:rPr lang="it-IT" dirty="0" err="1"/>
              <a:t>Glucose</a:t>
            </a:r>
            <a:r>
              <a:rPr lang="it-IT" dirty="0"/>
              <a:t> </a:t>
            </a:r>
            <a:r>
              <a:rPr lang="en-US" dirty="0"/>
              <a:t>50 mg/dL</a:t>
            </a:r>
          </a:p>
          <a:p>
            <a:r>
              <a:rPr lang="it-IT" dirty="0" err="1"/>
              <a:t>Calcium</a:t>
            </a:r>
            <a:r>
              <a:rPr lang="it-IT" dirty="0"/>
              <a:t> 9 mg/</a:t>
            </a:r>
            <a:r>
              <a:rPr lang="it-IT" dirty="0" err="1"/>
              <a:t>dL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84745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7E8D5F-4C72-BF48-9B15-3619F154E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25D872-9A28-034E-A96C-F58E2C0014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r>
              <a:rPr lang="en-US" dirty="0"/>
              <a:t>T </a:t>
            </a:r>
            <a:r>
              <a:rPr lang="en-US" dirty="0" err="1"/>
              <a:t>bili</a:t>
            </a:r>
            <a:r>
              <a:rPr lang="en-US" dirty="0"/>
              <a:t> 1.1 mg/dL</a:t>
            </a:r>
          </a:p>
          <a:p>
            <a:r>
              <a:rPr lang="en-US" dirty="0"/>
              <a:t>AST 42 units/L</a:t>
            </a:r>
          </a:p>
          <a:p>
            <a:r>
              <a:rPr lang="en-US" dirty="0"/>
              <a:t>ALT 55 units/L</a:t>
            </a:r>
          </a:p>
          <a:p>
            <a:r>
              <a:rPr lang="en-US" dirty="0"/>
              <a:t>Albumin 4.2 g/dL</a:t>
            </a:r>
          </a:p>
          <a:p>
            <a:r>
              <a:rPr lang="en-US" dirty="0" err="1"/>
              <a:t>Alk</a:t>
            </a:r>
            <a:r>
              <a:rPr lang="en-US" dirty="0"/>
              <a:t> </a:t>
            </a:r>
            <a:r>
              <a:rPr lang="en-US" dirty="0" err="1"/>
              <a:t>Phos</a:t>
            </a:r>
            <a:r>
              <a:rPr lang="en-US" dirty="0"/>
              <a:t> 72 units/L</a:t>
            </a:r>
          </a:p>
          <a:p>
            <a:r>
              <a:rPr lang="en-US" dirty="0"/>
              <a:t>Protein 8.1 g/d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5825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F5494-796C-2546-89C8-9468C9D44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ic aci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9171A5-D336-7D4A-8E98-131F24703E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Lactate 6.00 mg/dL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52588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05FC9-8067-A046-BBCD-CA1F055CC6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fluenz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E18E01-2C97-D04F-8E4A-DADD5B08C4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fluenza A – negative</a:t>
            </a:r>
          </a:p>
          <a:p>
            <a:r>
              <a:rPr lang="en-US" dirty="0"/>
              <a:t>Influenza B – negative </a:t>
            </a:r>
          </a:p>
        </p:txBody>
      </p:sp>
    </p:spTree>
    <p:extLst>
      <p:ext uri="{BB962C8B-B14F-4D97-AF65-F5344CB8AC3E}">
        <p14:creationId xmlns:p14="http://schemas.microsoft.com/office/powerpoint/2010/main" val="5850922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A344BE-6E38-BA46-A219-FC55FB0B0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5B4644-8DB6-774E-B609-9192BF0E36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62500" lnSpcReduction="20000"/>
          </a:bodyPr>
          <a:lstStyle/>
          <a:p>
            <a:r>
              <a:rPr lang="en-US" dirty="0"/>
              <a:t>Color - Yellow</a:t>
            </a:r>
          </a:p>
          <a:p>
            <a:r>
              <a:rPr lang="en-US" dirty="0"/>
              <a:t>Appearance - Clear</a:t>
            </a:r>
          </a:p>
          <a:p>
            <a:r>
              <a:rPr lang="en-US" dirty="0"/>
              <a:t>Specific gravity - 1.50</a:t>
            </a:r>
          </a:p>
          <a:p>
            <a:r>
              <a:rPr lang="en-US" dirty="0"/>
              <a:t>pH - 7.0</a:t>
            </a:r>
          </a:p>
          <a:p>
            <a:r>
              <a:rPr lang="it-IT" dirty="0" err="1"/>
              <a:t>Glucose</a:t>
            </a:r>
            <a:r>
              <a:rPr lang="it-IT" dirty="0"/>
              <a:t> - negative</a:t>
            </a:r>
            <a:endParaRPr lang="en-US" dirty="0"/>
          </a:p>
          <a:p>
            <a:r>
              <a:rPr lang="en-US" dirty="0"/>
              <a:t>Bilirubin - negative</a:t>
            </a:r>
          </a:p>
          <a:p>
            <a:r>
              <a:rPr lang="es-ES_tradnl" dirty="0" err="1"/>
              <a:t>Ketones</a:t>
            </a:r>
            <a:r>
              <a:rPr lang="es-ES_tradnl" dirty="0"/>
              <a:t> - </a:t>
            </a:r>
            <a:r>
              <a:rPr lang="en-US" dirty="0"/>
              <a:t>2+</a:t>
            </a:r>
          </a:p>
          <a:p>
            <a:r>
              <a:rPr lang="de-DE" dirty="0"/>
              <a:t>Protein - 2+</a:t>
            </a:r>
            <a:endParaRPr lang="en-US" dirty="0"/>
          </a:p>
          <a:p>
            <a:r>
              <a:rPr lang="it-IT" dirty="0"/>
              <a:t>Nitrite - negative</a:t>
            </a:r>
            <a:endParaRPr lang="en-US" dirty="0"/>
          </a:p>
          <a:p>
            <a:r>
              <a:rPr lang="en-US" dirty="0"/>
              <a:t>Leukocyte esterase - negative</a:t>
            </a:r>
          </a:p>
          <a:p>
            <a:r>
              <a:rPr lang="de-DE" dirty="0"/>
              <a:t>WBC - </a:t>
            </a:r>
            <a:r>
              <a:rPr lang="en-US" dirty="0"/>
              <a:t>2</a:t>
            </a:r>
            <a:r>
              <a:rPr lang="de-DE" dirty="0"/>
              <a:t>/</a:t>
            </a:r>
            <a:r>
              <a:rPr lang="de-DE" dirty="0" err="1"/>
              <a:t>hpf</a:t>
            </a:r>
            <a:endParaRPr lang="en-US" dirty="0"/>
          </a:p>
          <a:p>
            <a:r>
              <a:rPr lang="en-US" dirty="0"/>
              <a:t>RBC - 2</a:t>
            </a:r>
            <a:r>
              <a:rPr lang="de-DE" dirty="0"/>
              <a:t>/</a:t>
            </a:r>
            <a:r>
              <a:rPr lang="de-DE" dirty="0" err="1"/>
              <a:t>hpf</a:t>
            </a:r>
            <a:endParaRPr lang="en-US" dirty="0"/>
          </a:p>
          <a:p>
            <a:r>
              <a:rPr lang="en-US" dirty="0"/>
              <a:t>Squamous epithelial cells - 0-5/</a:t>
            </a:r>
            <a:r>
              <a:rPr lang="en-US" dirty="0" err="1"/>
              <a:t>hpf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68492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14D2C5-EA0D-434F-AC72-95F9EB9CE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C5F71F-F997-934C-A04A-C8BAEB5D10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it-IT" dirty="0" err="1"/>
              <a:t>Amphetamine</a:t>
            </a:r>
            <a:r>
              <a:rPr lang="it-IT" dirty="0"/>
              <a:t> - negative</a:t>
            </a:r>
            <a:endParaRPr lang="en-US" dirty="0"/>
          </a:p>
          <a:p>
            <a:r>
              <a:rPr lang="it-IT" dirty="0" err="1"/>
              <a:t>Barbiturate</a:t>
            </a:r>
            <a:r>
              <a:rPr lang="it-IT" dirty="0"/>
              <a:t> </a:t>
            </a:r>
            <a:r>
              <a:rPr lang="en-US" dirty="0"/>
              <a:t>– negative </a:t>
            </a:r>
          </a:p>
          <a:p>
            <a:r>
              <a:rPr lang="it-IT" dirty="0"/>
              <a:t>Benzodiazepine - </a:t>
            </a:r>
            <a:r>
              <a:rPr lang="en-US" dirty="0"/>
              <a:t>positive</a:t>
            </a:r>
          </a:p>
          <a:p>
            <a:r>
              <a:rPr lang="fr-FR" dirty="0" err="1"/>
              <a:t>Cocaine</a:t>
            </a:r>
            <a:r>
              <a:rPr lang="fr-FR" dirty="0"/>
              <a:t> - </a:t>
            </a:r>
            <a:r>
              <a:rPr lang="en-US" dirty="0"/>
              <a:t>negative</a:t>
            </a:r>
          </a:p>
          <a:p>
            <a:r>
              <a:rPr lang="en-US" dirty="0"/>
              <a:t>Marijuana - positive</a:t>
            </a:r>
          </a:p>
          <a:p>
            <a:r>
              <a:rPr lang="en-US" dirty="0"/>
              <a:t>Methadone - negative</a:t>
            </a:r>
          </a:p>
          <a:p>
            <a:r>
              <a:rPr lang="en-US" dirty="0"/>
              <a:t>Methamphetamine - negative</a:t>
            </a:r>
          </a:p>
          <a:p>
            <a:r>
              <a:rPr lang="it-IT" dirty="0"/>
              <a:t>Opiate - negative</a:t>
            </a:r>
            <a:endParaRPr lang="en-US" dirty="0"/>
          </a:p>
          <a:p>
            <a:r>
              <a:rPr lang="en-US" dirty="0" err="1"/>
              <a:t>Phenocyclidine</a:t>
            </a:r>
            <a:r>
              <a:rPr lang="en-US" dirty="0"/>
              <a:t> - negative</a:t>
            </a:r>
          </a:p>
          <a:p>
            <a:r>
              <a:rPr lang="en-US" dirty="0"/>
              <a:t>Tricyclic antidepressants - negative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4041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310</Words>
  <Application>Microsoft Macintosh PowerPoint</Application>
  <PresentationFormat>Widescreen</PresentationFormat>
  <Paragraphs>82</Paragraphs>
  <Slides>2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6" baseType="lpstr">
      <vt:lpstr>Arial</vt:lpstr>
      <vt:lpstr>Calibri</vt:lpstr>
      <vt:lpstr>Calibri Light</vt:lpstr>
      <vt:lpstr>Office Theme</vt:lpstr>
      <vt:lpstr>Skin Exam</vt:lpstr>
      <vt:lpstr>ECG</vt:lpstr>
      <vt:lpstr>CBC</vt:lpstr>
      <vt:lpstr>BMP</vt:lpstr>
      <vt:lpstr>Hepatic Function Panel</vt:lpstr>
      <vt:lpstr>Lactic acid</vt:lpstr>
      <vt:lpstr>Influenza</vt:lpstr>
      <vt:lpstr>UA</vt:lpstr>
      <vt:lpstr>UDS</vt:lpstr>
      <vt:lpstr>Ethanol</vt:lpstr>
      <vt:lpstr>Salicylate</vt:lpstr>
      <vt:lpstr>Acetominophen level</vt:lpstr>
      <vt:lpstr>Venous blood gas</vt:lpstr>
      <vt:lpstr>Osmolarity</vt:lpstr>
      <vt:lpstr>Coagulation factors</vt:lpstr>
      <vt:lpstr>D-dimer</vt:lpstr>
      <vt:lpstr>Fibrinogen</vt:lpstr>
      <vt:lpstr>Peripheral blood smear</vt:lpstr>
      <vt:lpstr>CXR</vt:lpstr>
      <vt:lpstr>CT Head</vt:lpstr>
      <vt:lpstr>Post-intubation CXR</vt:lpstr>
      <vt:lpstr>POCUS IVC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rita Vempati</dc:creator>
  <cp:lastModifiedBy>Amrita Vempati</cp:lastModifiedBy>
  <cp:revision>9</cp:revision>
  <dcterms:created xsi:type="dcterms:W3CDTF">2020-12-15T11:46:21Z</dcterms:created>
  <dcterms:modified xsi:type="dcterms:W3CDTF">2021-05-27T21:00:45Z</dcterms:modified>
</cp:coreProperties>
</file>